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907588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711000" y="744120"/>
            <a:ext cx="537516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8BDE64-8189-4E0D-B539-0ADA98D6AD99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sldImg"/>
          </p:nvPr>
        </p:nvSpPr>
        <p:spPr>
          <a:xfrm>
            <a:off x="711360" y="744480"/>
            <a:ext cx="5375160" cy="3722760"/>
          </a:xfrm>
          <a:prstGeom prst="rect">
            <a:avLst/>
          </a:prstGeom>
          <a:ln w="0">
            <a:noFill/>
          </a:ln>
        </p:spPr>
      </p:sp>
      <p:sp>
        <p:nvSpPr>
          <p:cNvPr id="123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fects of ds-miR-655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urchased from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harmac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スライド番号プレースホルダー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6DE01F-A3E2-4518-8459-D9D4D6BE4ED9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3DB26-47A0-476D-82C6-C54D8E29D9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1EB37-14F1-4F7B-A9CA-7F3D704F01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7DBF36-4B5C-4831-95A6-90429834438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B4C50D-6FC5-47DA-BCF2-E8C0BF12715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B66151-F5E3-477D-AA9B-3D3EF4B26B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38625A-67FC-4311-A962-E1F80676AC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1E9698-A478-4226-935C-2858D47D6A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E827E-A013-4BBC-9682-44902302D1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A80A4-FFE0-4F11-8431-3263210F47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9661B-5807-46D5-A58A-6A5A0A2243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705D5-56E7-4A0E-BD2C-1769D273F8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DB0B49-5E51-467B-AB69-4198E1B183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CB6EE2-7874-4457-BA1B-EFF958196AAC}" type="slidenum"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4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97"/>
          <p:cNvSpPr/>
          <p:nvPr/>
        </p:nvSpPr>
        <p:spPr>
          <a:xfrm>
            <a:off x="146160" y="139680"/>
            <a:ext cx="2314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直線コネクタ 247"/>
          <p:cNvSpPr/>
          <p:nvPr/>
        </p:nvSpPr>
        <p:spPr>
          <a:xfrm>
            <a:off x="3720960" y="211140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直線コネクタ 248"/>
          <p:cNvSpPr/>
          <p:nvPr/>
        </p:nvSpPr>
        <p:spPr>
          <a:xfrm>
            <a:off x="3765600" y="2111400"/>
            <a:ext cx="0" cy="1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直線コネクタ 249"/>
          <p:cNvSpPr/>
          <p:nvPr/>
        </p:nvSpPr>
        <p:spPr>
          <a:xfrm>
            <a:off x="3041640" y="2073240"/>
            <a:ext cx="90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直線コネクタ 250"/>
          <p:cNvSpPr/>
          <p:nvPr/>
        </p:nvSpPr>
        <p:spPr>
          <a:xfrm>
            <a:off x="3086280" y="2073240"/>
            <a:ext cx="0" cy="57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251"/>
          <p:cNvSpPr/>
          <p:nvPr/>
        </p:nvSpPr>
        <p:spPr>
          <a:xfrm>
            <a:off x="2471040" y="4484520"/>
            <a:ext cx="328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252"/>
          <p:cNvSpPr/>
          <p:nvPr/>
        </p:nvSpPr>
        <p:spPr>
          <a:xfrm>
            <a:off x="2538000" y="4208400"/>
            <a:ext cx="261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ZEB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2" descr="D:\VAIO desk top\MCG\Western Blotting\MDAMB231\120529 KP1N 231 Panc1 Dharmacon\20120528_KP1N 231 Panc1 Dharmacon NC 655_zeb1-2.img.tif"/>
          <p:cNvPicPr/>
          <p:nvPr/>
        </p:nvPicPr>
        <p:blipFill>
          <a:blip r:embed="rId1"/>
          <a:srcRect l="40688" t="46499" r="45558" b="47325"/>
          <a:stretch/>
        </p:blipFill>
        <p:spPr>
          <a:xfrm>
            <a:off x="3565440" y="4162320"/>
            <a:ext cx="576360" cy="2160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pic>
        <p:nvPicPr>
          <p:cNvPr id="56" name="Picture 3" descr="D:\VAIO desk top\MCG\Western Blotting\MDAMB231\120529 KP1N 231 Panc1 Dharmacon\20120528_KP1N 231 Panc1 Dharmacon NC 655_actb of zeb1.tif"/>
          <p:cNvPicPr/>
          <p:nvPr/>
        </p:nvPicPr>
        <p:blipFill>
          <a:blip r:embed="rId2"/>
          <a:srcRect l="43123" t="23653" r="42683" b="68349"/>
          <a:stretch/>
        </p:blipFill>
        <p:spPr>
          <a:xfrm>
            <a:off x="3565440" y="4437000"/>
            <a:ext cx="576360" cy="2160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sp>
        <p:nvSpPr>
          <p:cNvPr id="57" name="正方形/長方形 257"/>
          <p:cNvSpPr/>
          <p:nvPr/>
        </p:nvSpPr>
        <p:spPr>
          <a:xfrm>
            <a:off x="2765520" y="1746360"/>
            <a:ext cx="1530360" cy="22906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146"/>
          <p:cNvSpPr/>
          <p:nvPr/>
        </p:nvSpPr>
        <p:spPr>
          <a:xfrm rot="16200000">
            <a:off x="1413360" y="2830320"/>
            <a:ext cx="196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Relative expression ratio of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ZEB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 mR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259"/>
          <p:cNvSpPr/>
          <p:nvPr/>
        </p:nvSpPr>
        <p:spPr>
          <a:xfrm>
            <a:off x="2973600" y="5473800"/>
            <a:ext cx="37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an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正方形/長方形 260"/>
          <p:cNvSpPr/>
          <p:nvPr/>
        </p:nvSpPr>
        <p:spPr>
          <a:xfrm>
            <a:off x="3672000" y="2128680"/>
            <a:ext cx="187200" cy="190836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261"/>
          <p:cNvSpPr/>
          <p:nvPr/>
        </p:nvSpPr>
        <p:spPr>
          <a:xfrm>
            <a:off x="3729240" y="5473800"/>
            <a:ext cx="33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KP1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正方形/長方形 264"/>
          <p:cNvSpPr/>
          <p:nvPr/>
        </p:nvSpPr>
        <p:spPr>
          <a:xfrm>
            <a:off x="2992320" y="2128680"/>
            <a:ext cx="187560" cy="190836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直線コネクタ 265"/>
          <p:cNvSpPr/>
          <p:nvPr/>
        </p:nvSpPr>
        <p:spPr>
          <a:xfrm>
            <a:off x="2728800" y="212868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168"/>
          <p:cNvSpPr/>
          <p:nvPr/>
        </p:nvSpPr>
        <p:spPr>
          <a:xfrm>
            <a:off x="2531160" y="30225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169"/>
          <p:cNvSpPr/>
          <p:nvPr/>
        </p:nvSpPr>
        <p:spPr>
          <a:xfrm>
            <a:off x="2617920" y="39783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170"/>
          <p:cNvSpPr/>
          <p:nvPr/>
        </p:nvSpPr>
        <p:spPr>
          <a:xfrm>
            <a:off x="2531160" y="20700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直線コネクタ 269"/>
          <p:cNvSpPr/>
          <p:nvPr/>
        </p:nvSpPr>
        <p:spPr>
          <a:xfrm>
            <a:off x="2728800" y="403704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直線コネクタ 270"/>
          <p:cNvSpPr/>
          <p:nvPr/>
        </p:nvSpPr>
        <p:spPr>
          <a:xfrm>
            <a:off x="2728800" y="174636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テキスト ボックス 174"/>
          <p:cNvSpPr/>
          <p:nvPr/>
        </p:nvSpPr>
        <p:spPr>
          <a:xfrm>
            <a:off x="2531160" y="16812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テキスト ボックス 272"/>
          <p:cNvSpPr/>
          <p:nvPr/>
        </p:nvSpPr>
        <p:spPr>
          <a:xfrm rot="16200000">
            <a:off x="2728080" y="4940280"/>
            <a:ext cx="526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テキスト ボックス 273"/>
          <p:cNvSpPr/>
          <p:nvPr/>
        </p:nvSpPr>
        <p:spPr>
          <a:xfrm rot="16200000">
            <a:off x="2994480" y="4953600"/>
            <a:ext cx="54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直線コネクタ 274"/>
          <p:cNvSpPr/>
          <p:nvPr/>
        </p:nvSpPr>
        <p:spPr>
          <a:xfrm>
            <a:off x="2871720" y="5384880"/>
            <a:ext cx="576360" cy="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テキスト ボックス 275"/>
          <p:cNvSpPr/>
          <p:nvPr/>
        </p:nvSpPr>
        <p:spPr>
          <a:xfrm rot="16200000">
            <a:off x="3436200" y="4940280"/>
            <a:ext cx="526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テキスト ボックス 276"/>
          <p:cNvSpPr/>
          <p:nvPr/>
        </p:nvSpPr>
        <p:spPr>
          <a:xfrm rot="16200000">
            <a:off x="3718440" y="4953600"/>
            <a:ext cx="54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直線コネクタ 277"/>
          <p:cNvSpPr/>
          <p:nvPr/>
        </p:nvSpPr>
        <p:spPr>
          <a:xfrm>
            <a:off x="3610080" y="5384880"/>
            <a:ext cx="576000" cy="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直線コネクタ 281"/>
          <p:cNvSpPr/>
          <p:nvPr/>
        </p:nvSpPr>
        <p:spPr>
          <a:xfrm>
            <a:off x="2728800" y="308304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正方形/長方形 282"/>
          <p:cNvSpPr/>
          <p:nvPr/>
        </p:nvSpPr>
        <p:spPr>
          <a:xfrm>
            <a:off x="3181320" y="3273480"/>
            <a:ext cx="187200" cy="7635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直線コネクタ 283"/>
          <p:cNvSpPr/>
          <p:nvPr/>
        </p:nvSpPr>
        <p:spPr>
          <a:xfrm>
            <a:off x="3230640" y="323532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直線コネクタ 284"/>
          <p:cNvSpPr/>
          <p:nvPr/>
        </p:nvSpPr>
        <p:spPr>
          <a:xfrm>
            <a:off x="3274920" y="3235320"/>
            <a:ext cx="0" cy="39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正方形/長方形 285"/>
          <p:cNvSpPr/>
          <p:nvPr/>
        </p:nvSpPr>
        <p:spPr>
          <a:xfrm>
            <a:off x="3860640" y="3749760"/>
            <a:ext cx="187560" cy="2872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直線コネクタ 289"/>
          <p:cNvSpPr/>
          <p:nvPr/>
        </p:nvSpPr>
        <p:spPr>
          <a:xfrm>
            <a:off x="2765520" y="2128680"/>
            <a:ext cx="153036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テキスト ボックス 311"/>
          <p:cNvSpPr/>
          <p:nvPr/>
        </p:nvSpPr>
        <p:spPr>
          <a:xfrm>
            <a:off x="5342760" y="4494240"/>
            <a:ext cx="328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テキスト ボックス 312"/>
          <p:cNvSpPr/>
          <p:nvPr/>
        </p:nvSpPr>
        <p:spPr>
          <a:xfrm>
            <a:off x="5263560" y="4218120"/>
            <a:ext cx="407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GFBR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正方形/長方形 313"/>
          <p:cNvSpPr/>
          <p:nvPr/>
        </p:nvSpPr>
        <p:spPr>
          <a:xfrm>
            <a:off x="5637240" y="1754280"/>
            <a:ext cx="1477800" cy="229212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テキスト ボックス 146"/>
          <p:cNvSpPr/>
          <p:nvPr/>
        </p:nvSpPr>
        <p:spPr>
          <a:xfrm rot="16200000">
            <a:off x="4212000" y="2838960"/>
            <a:ext cx="210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Relative expression ratio of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TGFBR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 mR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テキスト ボックス 315"/>
          <p:cNvSpPr/>
          <p:nvPr/>
        </p:nvSpPr>
        <p:spPr>
          <a:xfrm>
            <a:off x="5845320" y="5481720"/>
            <a:ext cx="37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an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テキスト ボックス 317"/>
          <p:cNvSpPr/>
          <p:nvPr/>
        </p:nvSpPr>
        <p:spPr>
          <a:xfrm>
            <a:off x="6575760" y="5481720"/>
            <a:ext cx="33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KP1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直線コネクタ 321"/>
          <p:cNvSpPr/>
          <p:nvPr/>
        </p:nvSpPr>
        <p:spPr>
          <a:xfrm>
            <a:off x="5600880" y="213840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テキスト ボックス 168"/>
          <p:cNvSpPr/>
          <p:nvPr/>
        </p:nvSpPr>
        <p:spPr>
          <a:xfrm>
            <a:off x="5403240" y="303048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テキスト ボックス 169"/>
          <p:cNvSpPr/>
          <p:nvPr/>
        </p:nvSpPr>
        <p:spPr>
          <a:xfrm>
            <a:off x="5489640" y="39862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テキスト ボックス 170"/>
          <p:cNvSpPr/>
          <p:nvPr/>
        </p:nvSpPr>
        <p:spPr>
          <a:xfrm>
            <a:off x="5403240" y="207792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直線コネクタ 325"/>
          <p:cNvSpPr/>
          <p:nvPr/>
        </p:nvSpPr>
        <p:spPr>
          <a:xfrm>
            <a:off x="5600880" y="404640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直線コネクタ 326"/>
          <p:cNvSpPr/>
          <p:nvPr/>
        </p:nvSpPr>
        <p:spPr>
          <a:xfrm>
            <a:off x="5600880" y="175428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テキスト ボックス 174"/>
          <p:cNvSpPr/>
          <p:nvPr/>
        </p:nvSpPr>
        <p:spPr>
          <a:xfrm>
            <a:off x="5403240" y="16905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テキスト ボックス 328"/>
          <p:cNvSpPr/>
          <p:nvPr/>
        </p:nvSpPr>
        <p:spPr>
          <a:xfrm rot="16200000">
            <a:off x="5600160" y="4948920"/>
            <a:ext cx="526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テキスト ボックス 329"/>
          <p:cNvSpPr/>
          <p:nvPr/>
        </p:nvSpPr>
        <p:spPr>
          <a:xfrm rot="16200000">
            <a:off x="5866200" y="4961520"/>
            <a:ext cx="54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直線コネクタ 330"/>
          <p:cNvSpPr/>
          <p:nvPr/>
        </p:nvSpPr>
        <p:spPr>
          <a:xfrm>
            <a:off x="5743440" y="5392800"/>
            <a:ext cx="576360" cy="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テキスト ボックス 331"/>
          <p:cNvSpPr/>
          <p:nvPr/>
        </p:nvSpPr>
        <p:spPr>
          <a:xfrm rot="16200000">
            <a:off x="6282720" y="4948920"/>
            <a:ext cx="526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テキスト ボックス 332"/>
          <p:cNvSpPr/>
          <p:nvPr/>
        </p:nvSpPr>
        <p:spPr>
          <a:xfrm rot="16200000">
            <a:off x="6564960" y="4961520"/>
            <a:ext cx="54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直線コネクタ 333"/>
          <p:cNvSpPr/>
          <p:nvPr/>
        </p:nvSpPr>
        <p:spPr>
          <a:xfrm>
            <a:off x="6456240" y="5392800"/>
            <a:ext cx="576360" cy="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直線コネクタ 337"/>
          <p:cNvSpPr/>
          <p:nvPr/>
        </p:nvSpPr>
        <p:spPr>
          <a:xfrm>
            <a:off x="5600880" y="30909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直線コネクタ 338"/>
          <p:cNvSpPr/>
          <p:nvPr/>
        </p:nvSpPr>
        <p:spPr>
          <a:xfrm>
            <a:off x="5637240" y="2138400"/>
            <a:ext cx="147960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3" name="Picture 3" descr="F:\VAIO desk top\MCG\Western Blotting\Panc1_miR treatment\120809 Dharmacon NC 655\20120809_Dharmacon Panc1 NC 655_tgfbr2.tif"/>
          <p:cNvPicPr/>
          <p:nvPr/>
        </p:nvPicPr>
        <p:blipFill>
          <a:blip r:embed="rId3"/>
          <a:srcRect l="49920" t="26874" r="34785" b="64530"/>
          <a:stretch/>
        </p:blipFill>
        <p:spPr>
          <a:xfrm>
            <a:off x="5743440" y="4170240"/>
            <a:ext cx="576360" cy="2160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pic>
        <p:nvPicPr>
          <p:cNvPr id="104" name="Picture 2" descr="F:\VAIO desk top\MCG\Western Blotting\Panc1_miR treatment\120809 Dharmacon NC 655\20120809_Dharmacon Panc1 NC 655_actb.img.tif"/>
          <p:cNvPicPr/>
          <p:nvPr/>
        </p:nvPicPr>
        <p:blipFill>
          <a:blip r:embed="rId4"/>
          <a:srcRect l="50975" t="47775" r="33025" b="45561"/>
          <a:stretch/>
        </p:blipFill>
        <p:spPr>
          <a:xfrm>
            <a:off x="5743440" y="4437000"/>
            <a:ext cx="576360" cy="21744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pic>
        <p:nvPicPr>
          <p:cNvPr id="105" name="Picture 4" descr="F:\VAIO desk top\MCG\Western Blotting\Panc1_miR treatment\120809 Dharmacon NC 655\20120809_Dharmacon Panc1 NC 655_zeb1.img.tif"/>
          <p:cNvPicPr/>
          <p:nvPr/>
        </p:nvPicPr>
        <p:blipFill>
          <a:blip r:embed="rId5"/>
          <a:srcRect l="26170" t="55635" r="58062" b="37917"/>
          <a:stretch/>
        </p:blipFill>
        <p:spPr>
          <a:xfrm>
            <a:off x="2873520" y="4164120"/>
            <a:ext cx="576000" cy="21564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pic>
        <p:nvPicPr>
          <p:cNvPr id="106" name="Picture 143" descr="F:\VAIO desk top\MCG\Western Blotting\Panc1_miR treatment\120809 Dharmacon NC 655\20120809_Dharmacon Panc1 NC 655_actb.img.tif"/>
          <p:cNvPicPr/>
          <p:nvPr/>
        </p:nvPicPr>
        <p:blipFill>
          <a:blip r:embed="rId6"/>
          <a:srcRect l="24988" t="47559" r="57237" b="42389"/>
          <a:stretch/>
        </p:blipFill>
        <p:spPr>
          <a:xfrm>
            <a:off x="2873520" y="4435560"/>
            <a:ext cx="576000" cy="21744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pic>
        <p:nvPicPr>
          <p:cNvPr id="107" name="Picture 2" descr="F:\VAIO desk top\MCG\Western Blotting\Panc1_miR treatment\120808 Dharmacon NC 655\20120807_Dharmacon NC 655 KP1N_TGFBR2.tif..img.tif"/>
          <p:cNvPicPr/>
          <p:nvPr/>
        </p:nvPicPr>
        <p:blipFill>
          <a:blip r:embed="rId7"/>
          <a:srcRect l="42462" t="61818" r="41538" b="29046"/>
          <a:stretch/>
        </p:blipFill>
        <p:spPr>
          <a:xfrm>
            <a:off x="6424560" y="4170240"/>
            <a:ext cx="576360" cy="2160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pic>
        <p:nvPicPr>
          <p:cNvPr id="108" name="Picture 8" descr="F:\VAIO desk top\MCG\Western Blotting\Panc1_miR treatment\120808 Dharmacon NC 655\20120807_Dharmacon NC 655 Panc1_actb.img.tif"/>
          <p:cNvPicPr/>
          <p:nvPr/>
        </p:nvPicPr>
        <p:blipFill>
          <a:blip r:embed="rId8"/>
          <a:srcRect l="45154" t="44611" r="39298" b="47329"/>
          <a:stretch/>
        </p:blipFill>
        <p:spPr>
          <a:xfrm>
            <a:off x="6424560" y="4437000"/>
            <a:ext cx="576360" cy="2160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sp>
        <p:nvSpPr>
          <p:cNvPr id="109" name="直線コネクタ 120"/>
          <p:cNvSpPr/>
          <p:nvPr/>
        </p:nvSpPr>
        <p:spPr>
          <a:xfrm>
            <a:off x="6554880" y="208116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直線コネクタ 121"/>
          <p:cNvSpPr/>
          <p:nvPr/>
        </p:nvSpPr>
        <p:spPr>
          <a:xfrm>
            <a:off x="6599160" y="2081160"/>
            <a:ext cx="0" cy="57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直線コネクタ 122"/>
          <p:cNvSpPr/>
          <p:nvPr/>
        </p:nvSpPr>
        <p:spPr>
          <a:xfrm>
            <a:off x="5907240" y="1947960"/>
            <a:ext cx="90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直線コネクタ 123"/>
          <p:cNvSpPr/>
          <p:nvPr/>
        </p:nvSpPr>
        <p:spPr>
          <a:xfrm>
            <a:off x="5951520" y="1947960"/>
            <a:ext cx="0" cy="190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正方形/長方形 129"/>
          <p:cNvSpPr/>
          <p:nvPr/>
        </p:nvSpPr>
        <p:spPr>
          <a:xfrm>
            <a:off x="6505560" y="2138400"/>
            <a:ext cx="187200" cy="190800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正方形/長方形 133"/>
          <p:cNvSpPr/>
          <p:nvPr/>
        </p:nvSpPr>
        <p:spPr>
          <a:xfrm>
            <a:off x="5857920" y="2138400"/>
            <a:ext cx="187200" cy="190800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正方形/長方形 171"/>
          <p:cNvSpPr/>
          <p:nvPr/>
        </p:nvSpPr>
        <p:spPr>
          <a:xfrm>
            <a:off x="6045120" y="2671920"/>
            <a:ext cx="187560" cy="1374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直線コネクタ 172"/>
          <p:cNvSpPr/>
          <p:nvPr/>
        </p:nvSpPr>
        <p:spPr>
          <a:xfrm>
            <a:off x="6094440" y="265104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直線コネクタ 173"/>
          <p:cNvSpPr/>
          <p:nvPr/>
        </p:nvSpPr>
        <p:spPr>
          <a:xfrm>
            <a:off x="6138720" y="2651040"/>
            <a:ext cx="0" cy="17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正方形/長方形 174"/>
          <p:cNvSpPr/>
          <p:nvPr/>
        </p:nvSpPr>
        <p:spPr>
          <a:xfrm>
            <a:off x="6692760" y="2805120"/>
            <a:ext cx="187560" cy="12412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直線コネクタ 175"/>
          <p:cNvSpPr/>
          <p:nvPr/>
        </p:nvSpPr>
        <p:spPr>
          <a:xfrm>
            <a:off x="6742080" y="274788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直線コネクタ 176"/>
          <p:cNvSpPr/>
          <p:nvPr/>
        </p:nvSpPr>
        <p:spPr>
          <a:xfrm>
            <a:off x="6786720" y="2747880"/>
            <a:ext cx="0" cy="57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4"/>
          <p:cNvSpPr/>
          <p:nvPr/>
        </p:nvSpPr>
        <p:spPr>
          <a:xfrm>
            <a:off x="8102160" y="169920"/>
            <a:ext cx="1634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Harazono Y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et al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5T04:20:50Z</dcterms:created>
  <dc:creator>yosuke harazono</dc:creator>
  <dc:description/>
  <dc:language>en-US</dc:language>
  <cp:lastModifiedBy>MCG</cp:lastModifiedBy>
  <cp:lastPrinted>2012-08-28T05:49:27Z</cp:lastPrinted>
  <dcterms:modified xsi:type="dcterms:W3CDTF">2013-03-12T03:32:38Z</dcterms:modified>
  <cp:revision>268</cp:revision>
  <dc:subject/>
  <dc:title>PowerPoint プレゼンテーション</dc:title>
</cp:coreProperties>
</file>